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2"/>
  </p:notesMasterIdLst>
  <p:sldIdLst>
    <p:sldId id="256" r:id="rId2"/>
    <p:sldId id="268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D7396A-2C17-634C-AA9F-4668BB165DE1}" type="datetimeFigureOut">
              <a:rPr lang="en-US" smtClean="0"/>
              <a:t>10/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599665-7DF1-914D-BE09-F2FC28FE9E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4076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CG, VT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599665-7DF1-914D-BE09-F2FC28FE9EA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51223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CG, previous, sinus rhythm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599665-7DF1-914D-BE09-F2FC28FE9EA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54769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ECG, post conversion, ST-elevation myocardial infarction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599665-7DF1-914D-BE09-F2FC28FE9EA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88097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XR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599665-7DF1-914D-BE09-F2FC28FE9EA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9151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CB7FC7-5705-83E7-28F4-9D18D963014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1873209-38A9-30DD-EB8A-9E116DB1EB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414604-61CF-7192-A1C9-083D1FCEEE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34ADF-FE46-9246-A34B-003D3ED6BEBD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055981-D862-0B93-5592-DD9A8C5AE8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53365A-EF11-D5A7-D18F-B96F69C08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741DC-BA0F-5C4F-A5EA-7C7FF29D5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471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749176-71BE-8FB5-4CCF-9EB6B06DA2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E1A34DF-9F94-7C68-0B0B-5C6C2196EB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12E048-18B1-3EDC-EF72-4A7AF2C1A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34ADF-FE46-9246-A34B-003D3ED6BEBD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2F8A75-809B-7521-E014-8E14B05CA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85DA56-DA26-FA6B-11A0-F10FDB1A7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741DC-BA0F-5C4F-A5EA-7C7FF29D5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6519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ED0A403-0C23-C161-A636-985D64AA17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0C4EB2-A727-853A-4318-DFEFDFA3C9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C6D482-F33B-595A-2335-07203C8C1A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34ADF-FE46-9246-A34B-003D3ED6BEBD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AF89EE-F725-38AD-27A9-F4555306E1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08A80A-13C4-C43B-FDA6-4CA11E0FA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741DC-BA0F-5C4F-A5EA-7C7FF29D5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9007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43C6C2-2631-6C90-74ED-E52868057E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8806C5-DCA6-55F9-3F02-F46780EEF2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42AB41-70BC-897E-9706-F01ADCD56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34ADF-FE46-9246-A34B-003D3ED6BEBD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C33015-18B0-B993-8284-ED5FEF6328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80F28C-BD71-1B43-5AD2-555A5741A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741DC-BA0F-5C4F-A5EA-7C7FF29D5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047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61014C-7430-E91E-7352-10482CCA1A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A00BBF-2C11-5549-3C67-7DFD5BF99C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D77678-92CF-B4D9-785C-445113B09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34ADF-FE46-9246-A34B-003D3ED6BEBD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95D209-157C-E10E-5854-577BFE5B94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9653CF-F064-B12B-AADE-0F5D85D5D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741DC-BA0F-5C4F-A5EA-7C7FF29D5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308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0F596B-E59A-D898-F545-4A321AEA00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883147-BC61-F324-7842-343F4E125C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893231-6A1C-FFDF-8216-110C7BBDF2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145F8A-FF86-3ECF-E6A5-D554E998B7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34ADF-FE46-9246-A34B-003D3ED6BEBD}" type="datetimeFigureOut">
              <a:rPr lang="en-US" smtClean="0"/>
              <a:t>10/3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AC50FC-CBE6-18F7-AD5C-411BD85CA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2CE9AF-3D87-430D-084F-900B75B676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741DC-BA0F-5C4F-A5EA-7C7FF29D5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264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94540F-7B08-51C4-451A-2F9EF90CC7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03F52B-65B2-B664-ED10-3EDF96F40C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A08128-8FDE-4E1E-7E1C-7353BE6EF6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56B7382-7FFB-5E20-348E-0561B43034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59C6570-FB4B-A629-485C-CB699A888D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935BA2D-D95F-071E-FCBC-B1C17650AD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34ADF-FE46-9246-A34B-003D3ED6BEBD}" type="datetimeFigureOut">
              <a:rPr lang="en-US" smtClean="0"/>
              <a:t>10/3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B91E48E-385D-FD9B-1659-785D3BE69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130DE0E-A4C2-6E5E-F4FF-B74E56D5EE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741DC-BA0F-5C4F-A5EA-7C7FF29D5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010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0769E0-CE88-470E-76AF-DADC29EDE1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8E83022-1671-C4DB-B504-BF3A83C252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34ADF-FE46-9246-A34B-003D3ED6BEBD}" type="datetimeFigureOut">
              <a:rPr lang="en-US" smtClean="0"/>
              <a:t>10/3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E4DD798-3E20-7EFF-0E3D-EF776CD045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E586F9-75B6-FDBF-4DED-6FDDDE2CB7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741DC-BA0F-5C4F-A5EA-7C7FF29D5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8962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85821A-7211-466E-E33A-9153D9C3C6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34ADF-FE46-9246-A34B-003D3ED6BEBD}" type="datetimeFigureOut">
              <a:rPr lang="en-US" smtClean="0"/>
              <a:t>10/3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778646A-912B-57ED-4F0F-509DAB6DE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F4711DB-0523-0B0D-3398-BD3994BE4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741DC-BA0F-5C4F-A5EA-7C7FF29D5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333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489A17-B909-FDB6-4131-25C46DE05E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8A3FE5-B779-3E43-9C26-8646724757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F45282-CAF5-5AE8-2A02-CD3A682DDF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BF57CA-2B64-8DC8-1FDE-43DDC14F27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34ADF-FE46-9246-A34B-003D3ED6BEBD}" type="datetimeFigureOut">
              <a:rPr lang="en-US" smtClean="0"/>
              <a:t>10/3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0946BE-48DA-B093-FB03-A1EDD41E2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AA5A1D-A77E-0D10-8697-E06D1ED88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741DC-BA0F-5C4F-A5EA-7C7FF29D5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515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1CBF85-C70F-0BE4-9F03-79F2F71ACF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D6BBD49-C7E2-93C5-0519-2EF9FB8A9A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DFB19C-521D-0A27-E30B-7064C8340D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1CC5F8-0D6F-FD5F-8A20-0FFB136BF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34ADF-FE46-9246-A34B-003D3ED6BEBD}" type="datetimeFigureOut">
              <a:rPr lang="en-US" smtClean="0"/>
              <a:t>10/3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6A85E8-CFE8-0E1A-79BD-CC20A568BF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19DC7E-DC44-EBA9-9B90-EF383318D1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741DC-BA0F-5C4F-A5EA-7C7FF29D5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606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E5750CB-E29F-1909-CB6D-6447BF2257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8B2D14-B963-5602-B4BE-DFD2D242C5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5AF3A9-CCF7-252F-A179-9FE9DF3E64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D34ADF-FE46-9246-A34B-003D3ED6BEBD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CB452D-FE0F-1371-88EF-14AA2B932C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C604DB-CF9B-04D9-B2C2-FB65F94A95C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3741DC-BA0F-5C4F-A5EA-7C7FF29D5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4748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5" descr="A piece of paper with writing&#10;&#10;Description automatically generated with low confidence">
            <a:extLst>
              <a:ext uri="{FF2B5EF4-FFF2-40B4-BE49-F238E27FC236}">
                <a16:creationId xmlns:a16="http://schemas.microsoft.com/office/drawing/2014/main" id="{4824C14B-DE0B-1846-ACA3-F8BF1DF929B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153" y="407773"/>
            <a:ext cx="11891693" cy="64502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389308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293431A-2CFF-E75E-68D4-4820D26E77F6}"/>
              </a:ext>
            </a:extLst>
          </p:cNvPr>
          <p:cNvSpPr txBox="1"/>
          <p:nvPr/>
        </p:nvSpPr>
        <p:spPr>
          <a:xfrm>
            <a:off x="3048000" y="2870993"/>
            <a:ext cx="6096000" cy="11212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roponin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3.150 ng/m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62580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iagram&#10;&#10;Description automatically generated with low confidence">
            <a:extLst>
              <a:ext uri="{FF2B5EF4-FFF2-40B4-BE49-F238E27FC236}">
                <a16:creationId xmlns:a16="http://schemas.microsoft.com/office/drawing/2014/main" id="{8C37BD8D-06C3-D618-D12B-BB8407AF780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840828"/>
            <a:ext cx="12211237" cy="4939862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8819416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3C15D320-5490-9301-F9DA-9EF9CAC8C95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840259"/>
            <a:ext cx="12218233" cy="6017741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0695314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6A8135E-D912-16AC-9DA7-13D0A5A6F90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679" y="0"/>
            <a:ext cx="8460641" cy="68580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0393671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4836049-F21F-4B4E-33E7-5CA3EB4AB11E}"/>
              </a:ext>
            </a:extLst>
          </p:cNvPr>
          <p:cNvSpPr txBox="1"/>
          <p:nvPr/>
        </p:nvSpPr>
        <p:spPr>
          <a:xfrm>
            <a:off x="3049030" y="2037369"/>
            <a:ext cx="6098058" cy="278326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754380" algn="l"/>
              </a:tabLst>
            </a:pP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mplete blood count (CBC)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754380" algn="l"/>
              </a:tabLs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White blood count (WBC)   12.2 x1000/mm3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754380" algn="l"/>
              </a:tabLs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emoglobin (Hgb)    13.5 g/d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754380" algn="l"/>
              </a:tabLs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ematocrit (HCT)    34.0 %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754380" algn="l"/>
              </a:tabLs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latelet (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lt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    390 x1000/mm3 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05087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E213515-167C-496E-E058-411C3E07E3EC}"/>
              </a:ext>
            </a:extLst>
          </p:cNvPr>
          <p:cNvSpPr txBox="1"/>
          <p:nvPr/>
        </p:nvSpPr>
        <p:spPr>
          <a:xfrm>
            <a:off x="3048000" y="932000"/>
            <a:ext cx="6096000" cy="49992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754380" algn="l"/>
              </a:tabLst>
            </a:pP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asic metabolic panel (BMP)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754380" algn="l"/>
              </a:tabLs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odium      133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q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L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754380" algn="l"/>
              </a:tabLs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loride       99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q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L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754380" algn="l"/>
              </a:tabLs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otassium     4.5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q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L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754380" algn="l"/>
              </a:tabLs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icarbonate (HCO3)   26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q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L 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754380" algn="l"/>
              </a:tabLs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lood Urea Nitrogen (BUN)  34 mg/dL  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754380" algn="l"/>
              </a:tabLs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reatinine (Cr)     1.0 mg/dL 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754380" algn="l"/>
              </a:tabLs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lucose      140 mg/dL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754380" algn="l"/>
              </a:tabLs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alcium     8.0 mg/dL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70508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519D864-37A7-0EAB-4856-35B22ED06D37}"/>
              </a:ext>
            </a:extLst>
          </p:cNvPr>
          <p:cNvSpPr txBox="1"/>
          <p:nvPr/>
        </p:nvSpPr>
        <p:spPr>
          <a:xfrm>
            <a:off x="3048000" y="2870993"/>
            <a:ext cx="6096000" cy="11212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asic natriuretic peptid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20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g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m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38826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3E39B65-E832-A03F-1412-8099C6B6C199}"/>
              </a:ext>
            </a:extLst>
          </p:cNvPr>
          <p:cNvSpPr txBox="1"/>
          <p:nvPr/>
        </p:nvSpPr>
        <p:spPr>
          <a:xfrm>
            <a:off x="3048000" y="2870993"/>
            <a:ext cx="6096000" cy="11212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agnesium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.0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q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920875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D5AA882-9B20-3A48-4B12-1F932A84095B}"/>
              </a:ext>
            </a:extLst>
          </p:cNvPr>
          <p:cNvSpPr txBox="1"/>
          <p:nvPr/>
        </p:nvSpPr>
        <p:spPr>
          <a:xfrm>
            <a:off x="3048000" y="2870993"/>
            <a:ext cx="6096000" cy="11212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SH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.30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uIU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mL (0.550-4.780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uIU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mL)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8850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45</Words>
  <Application>Microsoft Macintosh PowerPoint</Application>
  <PresentationFormat>Widescreen</PresentationFormat>
  <Paragraphs>30</Paragraphs>
  <Slides>10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ohey, Shannon</dc:creator>
  <cp:lastModifiedBy>Toohey, Shannon</cp:lastModifiedBy>
  <cp:revision>1</cp:revision>
  <dcterms:created xsi:type="dcterms:W3CDTF">2023-10-03T23:17:25Z</dcterms:created>
  <dcterms:modified xsi:type="dcterms:W3CDTF">2023-10-03T23:20:43Z</dcterms:modified>
</cp:coreProperties>
</file>